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um" initials="w" lastIdx="2" clrIdx="0">
    <p:extLst>
      <p:ext uri="{19B8F6BF-5375-455C-9EA6-DF929625EA0E}">
        <p15:presenceInfo xmlns:p15="http://schemas.microsoft.com/office/powerpoint/2012/main" userId="wum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000" autoAdjust="0"/>
    <p:restoredTop sz="94660"/>
  </p:normalViewPr>
  <p:slideViewPr>
    <p:cSldViewPr snapToGrid="0">
      <p:cViewPr varScale="1">
        <p:scale>
          <a:sx n="99" d="100"/>
          <a:sy n="99" d="100"/>
        </p:scale>
        <p:origin x="67" y="4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um\Desktop\S&#322;u&#380;bowe\WUM%20&amp;%20UofL\Projekty%20-%20Wyniki\P2X7\Toksyczno&#347;&#263;%20AMPCP%20i%20ARL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um\Desktop\S&#322;u&#380;bowe\WUM%20&amp;%20UofL\Projekty%20-%20Wyniki\P2X7\Toksyczno&#347;&#263;%20AMPCP%20i%20ARL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um\Desktop\S&#322;u&#380;bowe\WUM%20&amp;%20UofL\Projekty%20-%20Wyniki\P2X7\Toksyczno&#347;&#263;%20AMPCP%20i%20ARL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um\Desktop\S&#322;u&#380;bowe\WUM%20&amp;%20UofL\Projekty%20-%20Wyniki\P2X7\Toksyczno&#347;&#263;%20AMPCP%20i%20AR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>
              <a:solidFill>
                <a:schemeClr val="bg1">
                  <a:lumMod val="50000"/>
                </a:schemeClr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chemeClr val="tx1"/>
                </a:solidFill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1-1F83-4DFC-9B61-5B76EFEC5677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I$3:$M$3</c:f>
                <c:numCache>
                  <c:formatCode>General</c:formatCode>
                  <c:ptCount val="5"/>
                  <c:pt idx="0">
                    <c:v>12.020815280171307</c:v>
                  </c:pt>
                  <c:pt idx="1">
                    <c:v>10.606601717798213</c:v>
                  </c:pt>
                  <c:pt idx="2">
                    <c:v>14.142135623730951</c:v>
                  </c:pt>
                  <c:pt idx="3">
                    <c:v>7.7781745930520225</c:v>
                  </c:pt>
                  <c:pt idx="4">
                    <c:v>15.556349186104045</c:v>
                  </c:pt>
                </c:numCache>
              </c:numRef>
            </c:plus>
            <c:minus>
              <c:numRef>
                <c:f>Sheet1!$I$3:$M$3</c:f>
                <c:numCache>
                  <c:formatCode>General</c:formatCode>
                  <c:ptCount val="5"/>
                  <c:pt idx="0">
                    <c:v>12.020815280171307</c:v>
                  </c:pt>
                  <c:pt idx="1">
                    <c:v>10.606601717798213</c:v>
                  </c:pt>
                  <c:pt idx="2">
                    <c:v>14.142135623730951</c:v>
                  </c:pt>
                  <c:pt idx="3">
                    <c:v>7.7781745930520225</c:v>
                  </c:pt>
                  <c:pt idx="4">
                    <c:v>15.556349186104045</c:v>
                  </c:pt>
                </c:numCache>
              </c:numRef>
            </c:minus>
            <c:spPr>
              <a:ln w="19050" cap="sq"/>
            </c:spPr>
          </c:errBars>
          <c:cat>
            <c:strRef>
              <c:f>Sheet1!$I$1:$M$1</c:f>
              <c:strCache>
                <c:ptCount val="5"/>
                <c:pt idx="0">
                  <c:v>Vehicle</c:v>
                </c:pt>
                <c:pt idx="1">
                  <c:v>10µM</c:v>
                </c:pt>
                <c:pt idx="2">
                  <c:v>30µM</c:v>
                </c:pt>
                <c:pt idx="3">
                  <c:v>50µM</c:v>
                </c:pt>
                <c:pt idx="4">
                  <c:v>100µM</c:v>
                </c:pt>
              </c:strCache>
            </c:strRef>
          </c:cat>
          <c:val>
            <c:numRef>
              <c:f>Sheet1!$I$2:$M$2</c:f>
              <c:numCache>
                <c:formatCode>General</c:formatCode>
                <c:ptCount val="5"/>
                <c:pt idx="0">
                  <c:v>73.5</c:v>
                </c:pt>
                <c:pt idx="1">
                  <c:v>72.5</c:v>
                </c:pt>
                <c:pt idx="2">
                  <c:v>74</c:v>
                </c:pt>
                <c:pt idx="3">
                  <c:v>74.5</c:v>
                </c:pt>
                <c:pt idx="4">
                  <c:v>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F83-4DFC-9B61-5B76EFEC56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1390712"/>
        <c:axId val="551391040"/>
      </c:barChart>
      <c:catAx>
        <c:axId val="551390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1391040"/>
        <c:crosses val="autoZero"/>
        <c:auto val="1"/>
        <c:lblAlgn val="ctr"/>
        <c:lblOffset val="100"/>
        <c:noMultiLvlLbl val="0"/>
      </c:catAx>
      <c:valAx>
        <c:axId val="55139104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 dirty="0"/>
                  <a:t>No. of </a:t>
                </a:r>
                <a:r>
                  <a:rPr lang="pl-PL" dirty="0" err="1"/>
                  <a:t>hBFU</a:t>
                </a:r>
                <a:r>
                  <a:rPr lang="pl-PL" dirty="0"/>
                  <a:t>-E </a:t>
                </a:r>
                <a:r>
                  <a:rPr lang="pl-PL" dirty="0" err="1"/>
                  <a:t>colonies</a:t>
                </a:r>
                <a:endParaRPr lang="pl-PL" dirty="0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139071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 b="1">
          <a:solidFill>
            <a:sysClr val="windowText" lastClr="000000"/>
          </a:solidFill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>
              <a:solidFill>
                <a:schemeClr val="bg1">
                  <a:lumMod val="50000"/>
                </a:schemeClr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chemeClr val="tx1"/>
                </a:solidFill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1-0CD6-491B-9F8D-02E7C5C866C7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I$27:$M$27</c:f>
                <c:numCache>
                  <c:formatCode>General</c:formatCode>
                  <c:ptCount val="5"/>
                  <c:pt idx="0">
                    <c:v>4.2426406871192848</c:v>
                  </c:pt>
                  <c:pt idx="1">
                    <c:v>7.0710678118654755</c:v>
                  </c:pt>
                  <c:pt idx="2">
                    <c:v>10.606601717798213</c:v>
                  </c:pt>
                  <c:pt idx="3">
                    <c:v>2.1213203435596424</c:v>
                  </c:pt>
                  <c:pt idx="4">
                    <c:v>11.313708498984761</c:v>
                  </c:pt>
                </c:numCache>
              </c:numRef>
            </c:plus>
            <c:minus>
              <c:numRef>
                <c:f>Sheet1!$I$27:$M$27</c:f>
                <c:numCache>
                  <c:formatCode>General</c:formatCode>
                  <c:ptCount val="5"/>
                  <c:pt idx="0">
                    <c:v>4.2426406871192848</c:v>
                  </c:pt>
                  <c:pt idx="1">
                    <c:v>7.0710678118654755</c:v>
                  </c:pt>
                  <c:pt idx="2">
                    <c:v>10.606601717798213</c:v>
                  </c:pt>
                  <c:pt idx="3">
                    <c:v>2.1213203435596424</c:v>
                  </c:pt>
                  <c:pt idx="4">
                    <c:v>11.313708498984761</c:v>
                  </c:pt>
                </c:numCache>
              </c:numRef>
            </c:minus>
            <c:spPr>
              <a:ln w="19050" cap="sq"/>
            </c:spPr>
          </c:errBars>
          <c:cat>
            <c:strRef>
              <c:f>Sheet1!$I$25:$M$25</c:f>
              <c:strCache>
                <c:ptCount val="5"/>
                <c:pt idx="0">
                  <c:v>Vehicle</c:v>
                </c:pt>
                <c:pt idx="1">
                  <c:v>10µM</c:v>
                </c:pt>
                <c:pt idx="2">
                  <c:v>30µM</c:v>
                </c:pt>
                <c:pt idx="3">
                  <c:v>50µM</c:v>
                </c:pt>
                <c:pt idx="4">
                  <c:v>100µM</c:v>
                </c:pt>
              </c:strCache>
            </c:strRef>
          </c:cat>
          <c:val>
            <c:numRef>
              <c:f>Sheet1!$I$26:$M$26</c:f>
              <c:numCache>
                <c:formatCode>General</c:formatCode>
                <c:ptCount val="5"/>
                <c:pt idx="0">
                  <c:v>62</c:v>
                </c:pt>
                <c:pt idx="1">
                  <c:v>67</c:v>
                </c:pt>
                <c:pt idx="2">
                  <c:v>71.5</c:v>
                </c:pt>
                <c:pt idx="3">
                  <c:v>75.5</c:v>
                </c:pt>
                <c:pt idx="4">
                  <c:v>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CD6-491B-9F8D-02E7C5C866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1390712"/>
        <c:axId val="551391040"/>
      </c:barChart>
      <c:catAx>
        <c:axId val="551390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1391040"/>
        <c:crosses val="autoZero"/>
        <c:auto val="1"/>
        <c:lblAlgn val="ctr"/>
        <c:lblOffset val="100"/>
        <c:noMultiLvlLbl val="0"/>
      </c:catAx>
      <c:valAx>
        <c:axId val="55139104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 dirty="0"/>
                  <a:t>No. of </a:t>
                </a:r>
                <a:r>
                  <a:rPr lang="pl-PL" dirty="0" err="1"/>
                  <a:t>hCFU</a:t>
                </a:r>
                <a:r>
                  <a:rPr lang="pl-PL" dirty="0"/>
                  <a:t>-GM</a:t>
                </a:r>
                <a:r>
                  <a:rPr lang="pl-PL" baseline="0" dirty="0"/>
                  <a:t> </a:t>
                </a:r>
                <a:r>
                  <a:rPr lang="pl-PL" dirty="0" err="1"/>
                  <a:t>colonies</a:t>
                </a:r>
                <a:endParaRPr lang="pl-PL" dirty="0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139071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 b="1">
          <a:solidFill>
            <a:sysClr val="windowText" lastClr="000000"/>
          </a:solidFill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>
              <a:solidFill>
                <a:schemeClr val="bg1">
                  <a:lumMod val="50000"/>
                </a:schemeClr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chemeClr val="tx1"/>
                </a:solidFill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1-DD63-44EE-94B6-BDD2843AD45D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I$69:$M$69</c:f>
                <c:numCache>
                  <c:formatCode>General</c:formatCode>
                  <c:ptCount val="5"/>
                  <c:pt idx="0">
                    <c:v>7.0710678118654755</c:v>
                  </c:pt>
                  <c:pt idx="1">
                    <c:v>2.8284271247461903</c:v>
                  </c:pt>
                  <c:pt idx="2">
                    <c:v>11.313708498984761</c:v>
                  </c:pt>
                  <c:pt idx="3">
                    <c:v>6.3639610306789276</c:v>
                  </c:pt>
                  <c:pt idx="4">
                    <c:v>2.8284271247461903</c:v>
                  </c:pt>
                </c:numCache>
              </c:numRef>
            </c:plus>
            <c:minus>
              <c:numRef>
                <c:f>Sheet1!$I$69:$M$69</c:f>
                <c:numCache>
                  <c:formatCode>General</c:formatCode>
                  <c:ptCount val="5"/>
                  <c:pt idx="0">
                    <c:v>7.0710678118654755</c:v>
                  </c:pt>
                  <c:pt idx="1">
                    <c:v>2.8284271247461903</c:v>
                  </c:pt>
                  <c:pt idx="2">
                    <c:v>11.313708498984761</c:v>
                  </c:pt>
                  <c:pt idx="3">
                    <c:v>6.3639610306789276</c:v>
                  </c:pt>
                  <c:pt idx="4">
                    <c:v>2.8284271247461903</c:v>
                  </c:pt>
                </c:numCache>
              </c:numRef>
            </c:minus>
            <c:spPr>
              <a:ln w="19050" cap="sq"/>
            </c:spPr>
          </c:errBars>
          <c:cat>
            <c:strRef>
              <c:f>Sheet1!$I$67:$M$67</c:f>
              <c:strCache>
                <c:ptCount val="5"/>
                <c:pt idx="0">
                  <c:v>Vehicle</c:v>
                </c:pt>
                <c:pt idx="1">
                  <c:v>10µM</c:v>
                </c:pt>
                <c:pt idx="2">
                  <c:v>30µM</c:v>
                </c:pt>
                <c:pt idx="3">
                  <c:v>50µM</c:v>
                </c:pt>
                <c:pt idx="4">
                  <c:v>100µM</c:v>
                </c:pt>
              </c:strCache>
            </c:strRef>
          </c:cat>
          <c:val>
            <c:numRef>
              <c:f>Sheet1!$I$68:$M$68</c:f>
              <c:numCache>
                <c:formatCode>General</c:formatCode>
                <c:ptCount val="5"/>
                <c:pt idx="0">
                  <c:v>123</c:v>
                </c:pt>
                <c:pt idx="1">
                  <c:v>121</c:v>
                </c:pt>
                <c:pt idx="2">
                  <c:v>121</c:v>
                </c:pt>
                <c:pt idx="3">
                  <c:v>125.5</c:v>
                </c:pt>
                <c:pt idx="4">
                  <c:v>1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D63-44EE-94B6-BDD2843AD4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1390712"/>
        <c:axId val="551391040"/>
      </c:barChart>
      <c:catAx>
        <c:axId val="551390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1391040"/>
        <c:crosses val="autoZero"/>
        <c:auto val="1"/>
        <c:lblAlgn val="ctr"/>
        <c:lblOffset val="100"/>
        <c:noMultiLvlLbl val="0"/>
      </c:catAx>
      <c:valAx>
        <c:axId val="55139104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 dirty="0"/>
                  <a:t>No. of </a:t>
                </a:r>
                <a:r>
                  <a:rPr lang="pl-PL" dirty="0" err="1"/>
                  <a:t>mCFU</a:t>
                </a:r>
                <a:r>
                  <a:rPr lang="pl-PL" dirty="0"/>
                  <a:t>-GM </a:t>
                </a:r>
                <a:r>
                  <a:rPr lang="pl-PL" dirty="0" err="1"/>
                  <a:t>colonies</a:t>
                </a:r>
                <a:endParaRPr lang="pl-PL" dirty="0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139071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 b="1">
          <a:solidFill>
            <a:sysClr val="windowText" lastClr="000000"/>
          </a:solidFill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>
              <a:solidFill>
                <a:schemeClr val="bg1">
                  <a:lumMod val="50000"/>
                </a:schemeClr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chemeClr val="tx1"/>
                </a:solidFill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1-94BE-4629-9DF5-55F7F96F820D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I$50:$M$50</c:f>
                <c:numCache>
                  <c:formatCode>General</c:formatCode>
                  <c:ptCount val="5"/>
                  <c:pt idx="0">
                    <c:v>9.8994949366116654</c:v>
                  </c:pt>
                  <c:pt idx="1">
                    <c:v>2.8284271247461903</c:v>
                  </c:pt>
                  <c:pt idx="2">
                    <c:v>10.606601717798213</c:v>
                  </c:pt>
                  <c:pt idx="3">
                    <c:v>3.5355339059327378</c:v>
                  </c:pt>
                  <c:pt idx="4">
                    <c:v>2.8284271247461903</c:v>
                  </c:pt>
                </c:numCache>
              </c:numRef>
            </c:plus>
            <c:minus>
              <c:numRef>
                <c:f>Sheet1!$I$50:$M$50</c:f>
                <c:numCache>
                  <c:formatCode>General</c:formatCode>
                  <c:ptCount val="5"/>
                  <c:pt idx="0">
                    <c:v>9.8994949366116654</c:v>
                  </c:pt>
                  <c:pt idx="1">
                    <c:v>2.8284271247461903</c:v>
                  </c:pt>
                  <c:pt idx="2">
                    <c:v>10.606601717798213</c:v>
                  </c:pt>
                  <c:pt idx="3">
                    <c:v>3.5355339059327378</c:v>
                  </c:pt>
                  <c:pt idx="4">
                    <c:v>2.8284271247461903</c:v>
                  </c:pt>
                </c:numCache>
              </c:numRef>
            </c:minus>
            <c:spPr>
              <a:ln w="19050" cap="sq"/>
            </c:spPr>
          </c:errBars>
          <c:cat>
            <c:strRef>
              <c:f>Sheet1!$I$48:$M$48</c:f>
              <c:strCache>
                <c:ptCount val="5"/>
                <c:pt idx="0">
                  <c:v>Vehicle</c:v>
                </c:pt>
                <c:pt idx="1">
                  <c:v>10µM</c:v>
                </c:pt>
                <c:pt idx="2">
                  <c:v>30µM</c:v>
                </c:pt>
                <c:pt idx="3">
                  <c:v>50µM</c:v>
                </c:pt>
                <c:pt idx="4">
                  <c:v>100µM</c:v>
                </c:pt>
              </c:strCache>
            </c:strRef>
          </c:cat>
          <c:val>
            <c:numRef>
              <c:f>Sheet1!$I$49:$M$49</c:f>
              <c:numCache>
                <c:formatCode>General</c:formatCode>
                <c:ptCount val="5"/>
                <c:pt idx="0">
                  <c:v>57</c:v>
                </c:pt>
                <c:pt idx="1">
                  <c:v>59</c:v>
                </c:pt>
                <c:pt idx="2">
                  <c:v>58.5</c:v>
                </c:pt>
                <c:pt idx="3">
                  <c:v>56.5</c:v>
                </c:pt>
                <c:pt idx="4">
                  <c:v>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4BE-4629-9DF5-55F7F96F82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1390712"/>
        <c:axId val="551391040"/>
      </c:barChart>
      <c:catAx>
        <c:axId val="551390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1391040"/>
        <c:crosses val="autoZero"/>
        <c:auto val="1"/>
        <c:lblAlgn val="ctr"/>
        <c:lblOffset val="100"/>
        <c:noMultiLvlLbl val="0"/>
      </c:catAx>
      <c:valAx>
        <c:axId val="55139104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 dirty="0"/>
                  <a:t>No. of </a:t>
                </a:r>
                <a:r>
                  <a:rPr lang="pl-PL" dirty="0" err="1"/>
                  <a:t>mBFU</a:t>
                </a:r>
                <a:r>
                  <a:rPr lang="pl-PL" dirty="0"/>
                  <a:t>-E </a:t>
                </a:r>
                <a:r>
                  <a:rPr lang="pl-PL" dirty="0" err="1"/>
                  <a:t>colonies</a:t>
                </a:r>
                <a:endParaRPr lang="pl-PL" dirty="0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139071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 b="1">
          <a:solidFill>
            <a:sysClr val="windowText" lastClr="000000"/>
          </a:solidFill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598DF392-3995-4E1C-9656-77EEA6400C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Podtytuł 2">
            <a:extLst>
              <a:ext uri="{FF2B5EF4-FFF2-40B4-BE49-F238E27FC236}">
                <a16:creationId xmlns:a16="http://schemas.microsoft.com/office/drawing/2014/main" id="{4E2F6FB1-855C-4775-979C-31F64D520F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1E3129CC-A7E9-4FBC-8F96-1E2436352F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586CFB72-5A20-496C-8265-CD4AF458DE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DAF446E2-39B2-4845-8773-DB4A37D719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776881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1437740E-527B-48FE-B5F7-6FED07C25D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id="{9F8B0B76-A9AC-408D-AA05-B2BAC88A79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72203568-1E2C-4820-B2D8-A355E3B67C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DC939C5C-51AA-4F44-A649-DBDEF63926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2B414A93-2D71-49C4-B67E-63108F6777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938534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>
            <a:extLst>
              <a:ext uri="{FF2B5EF4-FFF2-40B4-BE49-F238E27FC236}">
                <a16:creationId xmlns:a16="http://schemas.microsoft.com/office/drawing/2014/main" id="{B0CE0CC2-0278-42B8-8E4F-942FDA12176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id="{395881CF-0EFB-4D8F-9819-DA2B5ECB74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DFA768B3-C939-4B5C-8499-74D0A6A2DA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B3D97E62-1D31-47B1-A6D1-9BC37D9134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9521F2F0-36E1-499C-AFD1-C5B6D6D935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93379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A6B0A5CD-995D-4555-A0D8-B5B5C25409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34F5A3C4-3FCD-45C6-8186-FB8C233876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5CA11101-FB25-4D0C-86A6-A3B6599A31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AE27A5E1-A78C-4C07-8006-12B72BA5DA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8FA9D51E-6C6A-4ABE-BE4F-88AA548564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607641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BBD832E1-6E8F-4C54-8837-5D1210C320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969E5849-6F8B-4085-8050-2F07201F2D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4154C863-B039-4A57-A710-578D169DFB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5C7C92CF-0628-40A6-B0FF-D1A34BAAD2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FE6B8178-1701-4F4B-A24D-C7766D21B8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3839488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F7FBC52E-40B8-4A75-85E7-1E81633097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93E637A7-0A04-4898-8996-1CA176592CC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id="{F9A9A912-725D-4CAE-90AE-DF6E7E4D1A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76B6AE77-1C00-43DE-B199-26F2B63D18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7D284272-E0FF-4EDC-B59A-AE07B1E214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51E7E1DC-3BC2-400C-B6BB-8A1DA3C4EC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831744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35E4985A-21E0-401A-B3BB-4822E917B8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8EE44C59-2B4D-4DAF-BE77-56AE3D0064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id="{68768E04-3976-495D-8EB5-B0BCFB9F10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tekstu 4">
            <a:extLst>
              <a:ext uri="{FF2B5EF4-FFF2-40B4-BE49-F238E27FC236}">
                <a16:creationId xmlns:a16="http://schemas.microsoft.com/office/drawing/2014/main" id="{56A26610-187C-40C9-855A-DAA7CBF58F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Symbol zastępczy zawartości 5">
            <a:extLst>
              <a:ext uri="{FF2B5EF4-FFF2-40B4-BE49-F238E27FC236}">
                <a16:creationId xmlns:a16="http://schemas.microsoft.com/office/drawing/2014/main" id="{43F50FB2-FE70-492D-A17B-BB57F9E684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7" name="Symbol zastępczy daty 6">
            <a:extLst>
              <a:ext uri="{FF2B5EF4-FFF2-40B4-BE49-F238E27FC236}">
                <a16:creationId xmlns:a16="http://schemas.microsoft.com/office/drawing/2014/main" id="{64B93A6A-345F-4040-9F11-8E0FDBE4AB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8" name="Symbol zastępczy stopki 7">
            <a:extLst>
              <a:ext uri="{FF2B5EF4-FFF2-40B4-BE49-F238E27FC236}">
                <a16:creationId xmlns:a16="http://schemas.microsoft.com/office/drawing/2014/main" id="{BAAB5559-16BC-4A46-AECA-358C162DE4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>
            <a:extLst>
              <a:ext uri="{FF2B5EF4-FFF2-40B4-BE49-F238E27FC236}">
                <a16:creationId xmlns:a16="http://schemas.microsoft.com/office/drawing/2014/main" id="{9D1DA4E9-13BE-4BB4-9F8A-1B83BE29C5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9518184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700B1418-014F-4E0F-9E19-C9F47E7136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daty 2">
            <a:extLst>
              <a:ext uri="{FF2B5EF4-FFF2-40B4-BE49-F238E27FC236}">
                <a16:creationId xmlns:a16="http://schemas.microsoft.com/office/drawing/2014/main" id="{BB029A3C-D260-44F0-AA68-D87D4A758C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4" name="Symbol zastępczy stopki 3">
            <a:extLst>
              <a:ext uri="{FF2B5EF4-FFF2-40B4-BE49-F238E27FC236}">
                <a16:creationId xmlns:a16="http://schemas.microsoft.com/office/drawing/2014/main" id="{42A50736-2F1E-4C13-843E-2F47E2ECCE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>
            <a:extLst>
              <a:ext uri="{FF2B5EF4-FFF2-40B4-BE49-F238E27FC236}">
                <a16:creationId xmlns:a16="http://schemas.microsoft.com/office/drawing/2014/main" id="{1D722DB5-AA21-4BF7-91F9-8E520BFB74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241512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>
            <a:extLst>
              <a:ext uri="{FF2B5EF4-FFF2-40B4-BE49-F238E27FC236}">
                <a16:creationId xmlns:a16="http://schemas.microsoft.com/office/drawing/2014/main" id="{65C2B259-9A54-4DA2-9509-FCEAB3FF7F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3" name="Symbol zastępczy stopki 2">
            <a:extLst>
              <a:ext uri="{FF2B5EF4-FFF2-40B4-BE49-F238E27FC236}">
                <a16:creationId xmlns:a16="http://schemas.microsoft.com/office/drawing/2014/main" id="{F774EECF-18E4-463B-A6E6-94CEF8E997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>
            <a:extLst>
              <a:ext uri="{FF2B5EF4-FFF2-40B4-BE49-F238E27FC236}">
                <a16:creationId xmlns:a16="http://schemas.microsoft.com/office/drawing/2014/main" id="{4C3BE2BB-EA9E-425E-B047-652CA2AD05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0705982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D1A63E71-278F-456F-8AAC-428575ABC2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5F001588-7193-491E-8900-45218201EBA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id="{0456869C-63F6-4E7B-A438-A1518F7667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92C150A9-0D71-48D5-A657-BD73B589CA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9C445F6E-6E7E-4845-80A9-B501A141DF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1D4416BB-7695-4A8B-8397-1221EB7064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0484205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1724678D-BDB4-4EA1-9DAF-687E2548C1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obrazu 2">
            <a:extLst>
              <a:ext uri="{FF2B5EF4-FFF2-40B4-BE49-F238E27FC236}">
                <a16:creationId xmlns:a16="http://schemas.microsoft.com/office/drawing/2014/main" id="{1FF1504E-0A7C-4518-B084-C42FF1D781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id="{A038BCC4-9224-485C-9A33-BB5F24C056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916FF6B1-979E-42BE-8064-F1A5067986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201A9DAC-A8BD-41C4-8C1C-18E3C55159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B7682374-DD10-4BD0-83F5-BCD500F02A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72651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>
            <a:extLst>
              <a:ext uri="{FF2B5EF4-FFF2-40B4-BE49-F238E27FC236}">
                <a16:creationId xmlns:a16="http://schemas.microsoft.com/office/drawing/2014/main" id="{AFAF328F-09E4-4343-86B1-E30532F248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38C30F71-B30F-40E2-9386-F9DFBD1566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0FEBA0EC-FC42-4E6F-A866-0872AE8DF73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86CA4AE1-C50D-4DDD-9066-070497BEF4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3D709E13-D1F8-4E3D-9745-A79C3E949B4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97021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a 7">
            <a:extLst>
              <a:ext uri="{FF2B5EF4-FFF2-40B4-BE49-F238E27FC236}">
                <a16:creationId xmlns:a16="http://schemas.microsoft.com/office/drawing/2014/main" id="{ABB5E0D0-72FE-4845-803D-A024BDF8281C}"/>
              </a:ext>
            </a:extLst>
          </p:cNvPr>
          <p:cNvGrpSpPr/>
          <p:nvPr/>
        </p:nvGrpSpPr>
        <p:grpSpPr>
          <a:xfrm>
            <a:off x="952884" y="512647"/>
            <a:ext cx="10398247" cy="6105663"/>
            <a:chOff x="952884" y="512647"/>
            <a:chExt cx="10398247" cy="6105663"/>
          </a:xfrm>
        </p:grpSpPr>
        <p:graphicFrame>
          <p:nvGraphicFramePr>
            <p:cNvPr id="2" name="Chart 2">
              <a:extLst>
                <a:ext uri="{FF2B5EF4-FFF2-40B4-BE49-F238E27FC236}">
                  <a16:creationId xmlns:a16="http://schemas.microsoft.com/office/drawing/2014/main" id="{9CEC2525-E3AB-473C-A36F-4C177A82795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36249290"/>
                </p:ext>
              </p:extLst>
            </p:nvPr>
          </p:nvGraphicFramePr>
          <p:xfrm>
            <a:off x="1298464" y="838184"/>
            <a:ext cx="5040000" cy="28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" name="Chart 5">
              <a:extLst>
                <a:ext uri="{FF2B5EF4-FFF2-40B4-BE49-F238E27FC236}">
                  <a16:creationId xmlns:a16="http://schemas.microsoft.com/office/drawing/2014/main" id="{2E0C69F8-F0C9-4DB4-8C4B-E2E1AB6ED53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65469446"/>
                </p:ext>
              </p:extLst>
            </p:nvPr>
          </p:nvGraphicFramePr>
          <p:xfrm>
            <a:off x="6280716" y="838184"/>
            <a:ext cx="5040000" cy="28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4" name="Chart 8">
              <a:extLst>
                <a:ext uri="{FF2B5EF4-FFF2-40B4-BE49-F238E27FC236}">
                  <a16:creationId xmlns:a16="http://schemas.microsoft.com/office/drawing/2014/main" id="{D32CF907-2086-48B5-81D8-1C4D6043B32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37159899"/>
                </p:ext>
              </p:extLst>
            </p:nvPr>
          </p:nvGraphicFramePr>
          <p:xfrm>
            <a:off x="6280716" y="3724274"/>
            <a:ext cx="5040000" cy="28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5" name="Chart 9">
              <a:extLst>
                <a:ext uri="{FF2B5EF4-FFF2-40B4-BE49-F238E27FC236}">
                  <a16:creationId xmlns:a16="http://schemas.microsoft.com/office/drawing/2014/main" id="{06BAF49B-85FD-40B7-907D-706D6D73F0D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45110187"/>
                </p:ext>
              </p:extLst>
            </p:nvPr>
          </p:nvGraphicFramePr>
          <p:xfrm>
            <a:off x="1298464" y="3724274"/>
            <a:ext cx="5040000" cy="28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6" name="pole tekstowe 5">
              <a:extLst>
                <a:ext uri="{FF2B5EF4-FFF2-40B4-BE49-F238E27FC236}">
                  <a16:creationId xmlns:a16="http://schemas.microsoft.com/office/drawing/2014/main" id="{FB252C4B-75BF-4104-849B-42D831A226F3}"/>
                </a:ext>
              </a:extLst>
            </p:cNvPr>
            <p:cNvSpPr txBox="1"/>
            <p:nvPr/>
          </p:nvSpPr>
          <p:spPr>
            <a:xfrm>
              <a:off x="952884" y="512647"/>
              <a:ext cx="1039824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1600" b="1" dirty="0"/>
                <a:t>AMPCP</a:t>
              </a:r>
            </a:p>
          </p:txBody>
        </p:sp>
        <p:sp>
          <p:nvSpPr>
            <p:cNvPr id="7" name="Prostokąt 6">
              <a:extLst>
                <a:ext uri="{FF2B5EF4-FFF2-40B4-BE49-F238E27FC236}">
                  <a16:creationId xmlns:a16="http://schemas.microsoft.com/office/drawing/2014/main" id="{31708190-DB0D-49DA-BAEB-157BD08EA21C}"/>
                </a:ext>
              </a:extLst>
            </p:cNvPr>
            <p:cNvSpPr/>
            <p:nvPr/>
          </p:nvSpPr>
          <p:spPr>
            <a:xfrm>
              <a:off x="952884" y="512647"/>
              <a:ext cx="10398247" cy="6105663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  <p:sp>
        <p:nvSpPr>
          <p:cNvPr id="9" name="TextBox 1">
            <a:extLst>
              <a:ext uri="{FF2B5EF4-FFF2-40B4-BE49-F238E27FC236}">
                <a16:creationId xmlns:a16="http://schemas.microsoft.com/office/drawing/2014/main" id="{EE556FE7-337E-4ABD-8FE0-850295715CC1}"/>
              </a:ext>
            </a:extLst>
          </p:cNvPr>
          <p:cNvSpPr txBox="1"/>
          <p:nvPr/>
        </p:nvSpPr>
        <p:spPr>
          <a:xfrm>
            <a:off x="9429839" y="79135"/>
            <a:ext cx="2521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 err="1"/>
              <a:t>Supplementary</a:t>
            </a:r>
            <a:r>
              <a:rPr lang="en-US" b="1" dirty="0"/>
              <a:t> Figure </a:t>
            </a:r>
            <a:r>
              <a:rPr lang="pl-PL" b="1" dirty="0"/>
              <a:t>2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275107727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94</TotalTime>
  <Words>24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yw pakietu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wum</dc:creator>
  <cp:lastModifiedBy>Ratajczak,Mariusz</cp:lastModifiedBy>
  <cp:revision>75</cp:revision>
  <dcterms:created xsi:type="dcterms:W3CDTF">2019-07-02T07:51:08Z</dcterms:created>
  <dcterms:modified xsi:type="dcterms:W3CDTF">2019-08-04T02:30:23Z</dcterms:modified>
</cp:coreProperties>
</file>